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3" autoAdjust="0"/>
    <p:restoredTop sz="94660"/>
  </p:normalViewPr>
  <p:slideViewPr>
    <p:cSldViewPr snapToGrid="0">
      <p:cViewPr varScale="1">
        <p:scale>
          <a:sx n="94" d="100"/>
          <a:sy n="94" d="100"/>
        </p:scale>
        <p:origin x="96" y="6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00C4843-4F2C-30BC-0B7B-E948387079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BD79096-D219-E2FD-DA4B-3CAA970CD5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5441315-B351-5956-9B95-017FEA3D9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56A4539-EA94-6E74-6E87-198E360B9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E3CC1EF-5572-CE3F-F9FA-636C387B0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75311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031F6C5-1539-9343-1BAA-8C61AEDF7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95A488D-F891-2E29-B6F5-835DBE7ADA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19B6962-D047-B4B7-0838-62B659F53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0437DAC-FCB1-0552-A824-EFE41341E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7E6E5B-986D-6437-BED8-4D8DF8FF7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4797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E6E3601-17AB-F479-5168-B5F89DAE31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52090BF-0DC8-F963-3B28-607B0CDC22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08A8685-AB96-EA51-94B3-5730A391C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711241D-15B0-5552-5324-5E6D2B4A1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2DBCE92-0AAE-46A2-1EE2-A624785AE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8601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3C60AE-C5B4-2D86-800C-05D5D8C7D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CDC912B-942F-0696-A8A4-BC98E1B5E1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859FD92-C545-A1B8-E372-FFEC03D4F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A2A9760-4A16-388D-C181-EE927E765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F2E463C-AE6C-6C75-4DAF-40E143D79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04530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454D43-8BDD-BE42-F4BA-F8F52FFD2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82B30FC-F3B8-134D-D394-AD18EBB0F8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93A6583-6C9E-0DC8-790A-509563681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ABED263-00D8-F462-E43B-766865F1B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A40DAC-B4F5-4F47-6922-7BDE0BA15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0865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3F5D16-AE68-E591-3FF3-8734AA781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BF42DEC-B14B-A919-D678-03EDCF589E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842A64A-1878-34BA-7162-D3342226E9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822867A-C351-43AF-5A98-3A4F3FD90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DEE959F-187F-4DF1-3846-B54ED3467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00972CF-FBDE-56F9-C5A1-28DA4D3BC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45798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657D065-BD9F-8193-3FA8-BADCCAFFC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3D6178F-E9AE-39A2-FB4F-152DB9DFF8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EE324E2-4528-4754-C954-065A892AA8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D9ECB26-7F75-E7D8-0BC7-76252E24E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A87B2981-511B-ED80-3151-098AABB074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4366771-ECFF-AF35-9480-23B6B5562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D9B011E-8FB7-C1F8-57A6-5B1EE3581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9840A2F-48F7-109A-1A7D-98548CBB5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61233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285C05-ED68-7C0B-9A3E-70C931714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2A330E4-9170-F3F4-BE28-75F2CB977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98FA77E-3249-8A93-4011-C88A07DBA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1AEF354-4901-ECD4-83FE-F6109C3F9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90942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2098988-8CE9-4A35-3244-4F7085B28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BAFA881-604B-B655-979E-0A304159A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590B5A1-8D51-6134-ED15-28006EEE0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2010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70FCAE-AFBC-915B-A499-8F0C901F9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254300B-F2C8-C193-C680-6B4DFFCC1A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1BE4BE0-59A3-8B09-63A6-4207937966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9987971-FF82-4A5D-81C7-F87FDB9A6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7C3216B-F2C3-A9B5-7656-30B2689A0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077C901-26B1-3C4A-AB7A-2C7FB4EE3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3835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78B704-D216-AF75-EE57-ACDB09089C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EA2CF08-3B48-A09A-ADA5-5CA9BE9FCD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B36447F-07A7-4E59-4136-B80BC3826A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21A7A92-2949-068A-A8F4-32306C949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2C4CAF6-F7C0-BD9F-10E0-DC8856AB1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FE4887E-4FDC-8B5A-AAC2-2D27471F6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90772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1C556E7-F6A5-1D06-BE1E-12FB2B7B8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297920C-020C-F835-2B81-39E03E3EF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10D55F6-8825-5E4E-1E2F-82D12B7B7C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1159D2-B163-4FC9-AF68-9570513FDB89}" type="datetimeFigureOut">
              <a:rPr lang="es-CL" smtClean="0"/>
              <a:t>07-08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A511FA5-4CDF-3323-D84E-EE90A52FB4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2489BB1-FD31-5656-08B7-09F889722B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A2A076-1626-4413-B8E7-ECED575C3D59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34338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9A3E1929-60C5-EEF0-9B77-C199D6FE91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" y="398365"/>
            <a:ext cx="11425809" cy="388619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66191059-7039-2FB0-7E40-53679FE5F148}"/>
              </a:ext>
            </a:extLst>
          </p:cNvPr>
          <p:cNvSpPr txBox="1"/>
          <p:nvPr/>
        </p:nvSpPr>
        <p:spPr>
          <a:xfrm>
            <a:off x="166751" y="4162981"/>
            <a:ext cx="1153337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CL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  <a:p>
            <a:pPr algn="just"/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. Repeat of Figure 2D and 2E panels. Effect of ASA upon eicosanoid production in RAW cells infected with </a:t>
            </a:r>
            <a:r>
              <a:rPr lang="en-US" sz="18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. cruzi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2D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estern blot of COX-1 and COX-2 isoforms in RAW cells exposed to LPS 1 µg/mL (+LPS) or 3×10</a:t>
            </a:r>
            <a:r>
              <a:rPr lang="en-US" sz="18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6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8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. cruzi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ypomastigotes (+</a:t>
            </a:r>
            <a:r>
              <a:rPr lang="en-US" sz="18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 cruzi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. The right lane corresponds to a crude extract of </a:t>
            </a:r>
            <a:r>
              <a:rPr lang="en-US" sz="18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. cruzi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ypomastigote proteins. </a:t>
            </a:r>
            <a:r>
              <a:rPr lang="es-CL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β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actin (bottom panel) was used as a loading control. 2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Quantification of COX-1 and COX-2 blotting. The results are presented as the mean ± SD of four independent experiments. ****: p&lt;0001 compared with its respective uninfected control by two-way ANOVA.</a:t>
            </a:r>
            <a:endParaRPr lang="es-CL" sz="18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08374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4</Words>
  <Application>Microsoft Office PowerPoint</Application>
  <PresentationFormat>Panorámica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an Diego Maya Arango (jdmaya)</dc:creator>
  <cp:lastModifiedBy>Juan Diego Maya Arango (jdmaya)</cp:lastModifiedBy>
  <cp:revision>1</cp:revision>
  <dcterms:created xsi:type="dcterms:W3CDTF">2024-08-07T17:05:57Z</dcterms:created>
  <dcterms:modified xsi:type="dcterms:W3CDTF">2024-08-07T17:08:49Z</dcterms:modified>
</cp:coreProperties>
</file>